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50730-48E9-45C4-9EAD-0329999E3D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43BA20-950D-4B94-A83E-72CC1EBCAC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8678BB-B975-407F-9CB4-C2B3C12A251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51D970-93BF-4B40-BB58-316DFF7A02D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E12577-C268-4103-9838-82AA128449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443C2-5DA6-4231-A3F0-4675095F33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06BDB-1B6A-4AE2-BF3A-9E9527791C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2F88E-F040-4435-8DB4-48AB8867C3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732D4-26A2-4601-AA82-63636E5C2C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1845D-646B-4106-99A9-9860ECE65F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426C0-585A-429F-B957-42CF746EB5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989183-41DE-4484-9C1A-C0F38754AD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3A5A896-E278-4129-9ABC-56D6ECFB4ECC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2771640" y="189000"/>
            <a:ext cx="4695840" cy="4741920"/>
          </a:xfrm>
          <a:prstGeom prst="rect">
            <a:avLst/>
          </a:prstGeom>
          <a:ln w="0">
            <a:noFill/>
          </a:ln>
        </p:spPr>
      </p:pic>
      <p:sp>
        <p:nvSpPr>
          <p:cNvPr id="42" name="Rechteck 1"/>
          <p:cNvSpPr/>
          <p:nvPr/>
        </p:nvSpPr>
        <p:spPr>
          <a:xfrm>
            <a:off x="2771640" y="5084640"/>
            <a:ext cx="52452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. Fig. 1: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Metastasis free survival likeliehood statistics as described by Prat et al., (2012). To compare the amount of independent prognostic information provided by Ep-CAM (A) and AURKA (B) we estimated the likelihood ratio statistic in a model that already included AURKA (A) or Ep-CAM (B). The model shows that AURKA provides significant additional information over grading in the cohort of all patients, as well as in the ER+/HER2- subgroups (B). Vice versa, Ep-CAM provides additional information over AURKA only in the cohort of all patient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2T15:11:07Z</dcterms:created>
  <dc:creator>Schmidt, Marcus</dc:creator>
  <dc:description/>
  <dc:language>en-US</dc:language>
  <cp:lastModifiedBy>Schmidt, Marcus</cp:lastModifiedBy>
  <dcterms:modified xsi:type="dcterms:W3CDTF">2012-10-22T15:44:53Z</dcterms:modified>
  <cp:revision>5</cp:revision>
  <dc:subject/>
  <dc:title>PowerPoint-Präsentation</dc:title>
</cp:coreProperties>
</file>